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mmad Najafi" userId="51ea0d0baa713111" providerId="LiveId" clId="{4A3E8AD6-0C81-497A-B08C-AD6EFD6D2330}"/>
    <pc:docChg chg="undo custSel delSld modSld">
      <pc:chgData name="Mohammad Najafi" userId="51ea0d0baa713111" providerId="LiveId" clId="{4A3E8AD6-0C81-497A-B08C-AD6EFD6D2330}" dt="2025-12-22T12:26:10.053" v="44" actId="2696"/>
      <pc:docMkLst>
        <pc:docMk/>
      </pc:docMkLst>
      <pc:sldChg chg="addSp delSp modSp mod">
        <pc:chgData name="Mohammad Najafi" userId="51ea0d0baa713111" providerId="LiveId" clId="{4A3E8AD6-0C81-497A-B08C-AD6EFD6D2330}" dt="2025-12-22T12:23:59.009" v="37" actId="14100"/>
        <pc:sldMkLst>
          <pc:docMk/>
          <pc:sldMk cId="1576068377" sldId="257"/>
        </pc:sldMkLst>
        <pc:spChg chg="add mod">
          <ac:chgData name="Mohammad Najafi" userId="51ea0d0baa713111" providerId="LiveId" clId="{4A3E8AD6-0C81-497A-B08C-AD6EFD6D2330}" dt="2025-12-22T12:23:06.146" v="23" actId="20577"/>
          <ac:spMkLst>
            <pc:docMk/>
            <pc:sldMk cId="1576068377" sldId="257"/>
            <ac:spMk id="3" creationId="{AE408A06-2C2C-BCDA-B2B1-9B00E30BDB09}"/>
          </ac:spMkLst>
        </pc:spChg>
        <pc:spChg chg="mod">
          <ac:chgData name="Mohammad Najafi" userId="51ea0d0baa713111" providerId="LiveId" clId="{4A3E8AD6-0C81-497A-B08C-AD6EFD6D2330}" dt="2025-12-22T12:23:59.009" v="37" actId="14100"/>
          <ac:spMkLst>
            <pc:docMk/>
            <pc:sldMk cId="1576068377" sldId="257"/>
            <ac:spMk id="12" creationId="{C4F6734B-4566-E386-40ED-0ED541146602}"/>
          </ac:spMkLst>
        </pc:spChg>
        <pc:spChg chg="del mod">
          <ac:chgData name="Mohammad Najafi" userId="51ea0d0baa713111" providerId="LiveId" clId="{4A3E8AD6-0C81-497A-B08C-AD6EFD6D2330}" dt="2025-12-22T12:23:13.003" v="24" actId="478"/>
          <ac:spMkLst>
            <pc:docMk/>
            <pc:sldMk cId="1576068377" sldId="257"/>
            <ac:spMk id="14" creationId="{00000000-0000-0000-0000-000000000000}"/>
          </ac:spMkLst>
        </pc:spChg>
        <pc:spChg chg="mod">
          <ac:chgData name="Mohammad Najafi" userId="51ea0d0baa713111" providerId="LiveId" clId="{4A3E8AD6-0C81-497A-B08C-AD6EFD6D2330}" dt="2025-12-22T12:23:33.110" v="26" actId="1076"/>
          <ac:spMkLst>
            <pc:docMk/>
            <pc:sldMk cId="1576068377" sldId="257"/>
            <ac:spMk id="15" creationId="{C83AEE32-8DEC-A414-FB39-AD9F05C906CE}"/>
          </ac:spMkLst>
        </pc:spChg>
      </pc:sldChg>
      <pc:sldChg chg="modSp mod">
        <pc:chgData name="Mohammad Najafi" userId="51ea0d0baa713111" providerId="LiveId" clId="{4A3E8AD6-0C81-497A-B08C-AD6EFD6D2330}" dt="2025-12-22T12:25:42.612" v="41" actId="1076"/>
        <pc:sldMkLst>
          <pc:docMk/>
          <pc:sldMk cId="1193892961" sldId="259"/>
        </pc:sldMkLst>
        <pc:spChg chg="mod">
          <ac:chgData name="Mohammad Najafi" userId="51ea0d0baa713111" providerId="LiveId" clId="{4A3E8AD6-0C81-497A-B08C-AD6EFD6D2330}" dt="2025-12-22T12:25:42.612" v="41" actId="1076"/>
          <ac:spMkLst>
            <pc:docMk/>
            <pc:sldMk cId="1193892961" sldId="259"/>
            <ac:spMk id="12" creationId="{D28F5F14-FA82-A25E-9101-676A12F3C64A}"/>
          </ac:spMkLst>
        </pc:spChg>
        <pc:spChg chg="mod">
          <ac:chgData name="Mohammad Najafi" userId="51ea0d0baa713111" providerId="LiveId" clId="{4A3E8AD6-0C81-497A-B08C-AD6EFD6D2330}" dt="2025-12-22T12:21:50.415" v="15" actId="20577"/>
          <ac:spMkLst>
            <pc:docMk/>
            <pc:sldMk cId="1193892961" sldId="259"/>
            <ac:spMk id="14" creationId="{00000000-0000-0000-0000-000000000000}"/>
          </ac:spMkLst>
        </pc:spChg>
        <pc:picChg chg="mod">
          <ac:chgData name="Mohammad Najafi" userId="51ea0d0baa713111" providerId="LiveId" clId="{4A3E8AD6-0C81-497A-B08C-AD6EFD6D2330}" dt="2025-12-22T12:20:45.827" v="5" actId="1076"/>
          <ac:picMkLst>
            <pc:docMk/>
            <pc:sldMk cId="1193892961" sldId="259"/>
            <ac:picMk id="2" creationId="{00000000-0000-0000-0000-000000000000}"/>
          </ac:picMkLst>
        </pc:picChg>
      </pc:sldChg>
      <pc:sldChg chg="delSp del mod">
        <pc:chgData name="Mohammad Najafi" userId="51ea0d0baa713111" providerId="LiveId" clId="{4A3E8AD6-0C81-497A-B08C-AD6EFD6D2330}" dt="2025-12-22T12:26:10.053" v="44" actId="2696"/>
        <pc:sldMkLst>
          <pc:docMk/>
          <pc:sldMk cId="442676314" sldId="260"/>
        </pc:sldMkLst>
        <pc:spChg chg="del">
          <ac:chgData name="Mohammad Najafi" userId="51ea0d0baa713111" providerId="LiveId" clId="{4A3E8AD6-0C81-497A-B08C-AD6EFD6D2330}" dt="2025-12-22T12:26:03.390" v="43" actId="478"/>
          <ac:spMkLst>
            <pc:docMk/>
            <pc:sldMk cId="442676314" sldId="260"/>
            <ac:spMk id="3" creationId="{00000000-0000-0000-0000-000000000000}"/>
          </ac:spMkLst>
        </pc:spChg>
        <pc:picChg chg="del">
          <ac:chgData name="Mohammad Najafi" userId="51ea0d0baa713111" providerId="LiveId" clId="{4A3E8AD6-0C81-497A-B08C-AD6EFD6D2330}" dt="2025-12-22T12:25:58.379" v="42" actId="478"/>
          <ac:picMkLst>
            <pc:docMk/>
            <pc:sldMk cId="442676314" sldId="260"/>
            <ac:picMk id="2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7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58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908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048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631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38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479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68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428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235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377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C7806-C998-47D6-BA76-6A05C693CA6E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9ACFA-7B3E-40E7-81D1-7AA5BAA5B2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54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554" y="1632283"/>
            <a:ext cx="6858000" cy="444398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91D0F66-CFD1-267D-4305-0D3547F6E6B9}"/>
              </a:ext>
            </a:extLst>
          </p:cNvPr>
          <p:cNvSpPr txBox="1"/>
          <p:nvPr/>
        </p:nvSpPr>
        <p:spPr>
          <a:xfrm>
            <a:off x="2525579" y="5364415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348ACF8-95A3-82C6-D409-7BC61C534992}"/>
              </a:ext>
            </a:extLst>
          </p:cNvPr>
          <p:cNvSpPr txBox="1"/>
          <p:nvPr/>
        </p:nvSpPr>
        <p:spPr>
          <a:xfrm>
            <a:off x="2525579" y="4993648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09F4BB8-5880-E58C-F885-0D2BC5809AC9}"/>
              </a:ext>
            </a:extLst>
          </p:cNvPr>
          <p:cNvSpPr txBox="1"/>
          <p:nvPr/>
        </p:nvSpPr>
        <p:spPr>
          <a:xfrm>
            <a:off x="2563509" y="4464167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B9AEBC4-B6AF-650B-7258-91443F23AED0}"/>
              </a:ext>
            </a:extLst>
          </p:cNvPr>
          <p:cNvSpPr txBox="1"/>
          <p:nvPr/>
        </p:nvSpPr>
        <p:spPr>
          <a:xfrm>
            <a:off x="2575085" y="3700387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428E893-2875-1FB2-FE7A-D1CB04EF97F3}"/>
              </a:ext>
            </a:extLst>
          </p:cNvPr>
          <p:cNvSpPr txBox="1"/>
          <p:nvPr/>
        </p:nvSpPr>
        <p:spPr>
          <a:xfrm>
            <a:off x="2604083" y="2885375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C80377-55DC-F112-4ADE-6132CF4072E4}"/>
              </a:ext>
            </a:extLst>
          </p:cNvPr>
          <p:cNvSpPr txBox="1"/>
          <p:nvPr/>
        </p:nvSpPr>
        <p:spPr>
          <a:xfrm>
            <a:off x="2525579" y="2422911"/>
            <a:ext cx="891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5A4198-79A5-BF7E-67A4-6C1BC349B00F}"/>
              </a:ext>
            </a:extLst>
          </p:cNvPr>
          <p:cNvSpPr txBox="1"/>
          <p:nvPr/>
        </p:nvSpPr>
        <p:spPr>
          <a:xfrm>
            <a:off x="2525579" y="2109878"/>
            <a:ext cx="889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AABD21C-DA0B-AEF2-C81A-0DC17721F8CA}"/>
              </a:ext>
            </a:extLst>
          </p:cNvPr>
          <p:cNvSpPr txBox="1"/>
          <p:nvPr/>
        </p:nvSpPr>
        <p:spPr>
          <a:xfrm>
            <a:off x="2563509" y="1779590"/>
            <a:ext cx="889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83AEE32-8DEC-A414-FB39-AD9F05C906CE}"/>
              </a:ext>
            </a:extLst>
          </p:cNvPr>
          <p:cNvSpPr txBox="1"/>
          <p:nvPr/>
        </p:nvSpPr>
        <p:spPr>
          <a:xfrm>
            <a:off x="3520819" y="1486103"/>
            <a:ext cx="734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8F5F14-FA82-A25E-9101-676A12F3C64A}"/>
              </a:ext>
            </a:extLst>
          </p:cNvPr>
          <p:cNvSpPr txBox="1"/>
          <p:nvPr/>
        </p:nvSpPr>
        <p:spPr>
          <a:xfrm>
            <a:off x="2423450" y="1191602"/>
            <a:ext cx="10146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502229" y="5943452"/>
            <a:ext cx="96665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+mj-cs"/>
              </a:rPr>
              <a:t>Supplement 4A: Western Blot of VAV2 Protein. </a:t>
            </a:r>
          </a:p>
          <a:p>
            <a:r>
              <a:rPr lang="en-US" sz="1400" b="1" dirty="0">
                <a:cs typeface="+mj-cs"/>
              </a:rPr>
              <a:t>N(normal) and T(tumor)</a:t>
            </a:r>
            <a:endParaRPr lang="en-US" sz="14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1193892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7477" y="1615921"/>
            <a:ext cx="6857731" cy="44394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91D0F66-CFD1-267D-4305-0D3547F6E6B9}"/>
              </a:ext>
            </a:extLst>
          </p:cNvPr>
          <p:cNvSpPr txBox="1"/>
          <p:nvPr/>
        </p:nvSpPr>
        <p:spPr>
          <a:xfrm>
            <a:off x="2302678" y="5304279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48ACF8-95A3-82C6-D409-7BC61C534992}"/>
              </a:ext>
            </a:extLst>
          </p:cNvPr>
          <p:cNvSpPr txBox="1"/>
          <p:nvPr/>
        </p:nvSpPr>
        <p:spPr>
          <a:xfrm>
            <a:off x="2302678" y="4934281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09F4BB8-5880-E58C-F885-0D2BC5809AC9}"/>
              </a:ext>
            </a:extLst>
          </p:cNvPr>
          <p:cNvSpPr txBox="1"/>
          <p:nvPr/>
        </p:nvSpPr>
        <p:spPr>
          <a:xfrm>
            <a:off x="2302678" y="4350594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9AEBC4-B6AF-650B-7258-91443F23AED0}"/>
              </a:ext>
            </a:extLst>
          </p:cNvPr>
          <p:cNvSpPr txBox="1"/>
          <p:nvPr/>
        </p:nvSpPr>
        <p:spPr>
          <a:xfrm>
            <a:off x="2372398" y="3416706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428E893-2875-1FB2-FE7A-D1CB04EF97F3}"/>
              </a:ext>
            </a:extLst>
          </p:cNvPr>
          <p:cNvSpPr txBox="1"/>
          <p:nvPr/>
        </p:nvSpPr>
        <p:spPr>
          <a:xfrm>
            <a:off x="2375253" y="2863539"/>
            <a:ext cx="734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C80377-55DC-F112-4ADE-6132CF4072E4}"/>
              </a:ext>
            </a:extLst>
          </p:cNvPr>
          <p:cNvSpPr txBox="1"/>
          <p:nvPr/>
        </p:nvSpPr>
        <p:spPr>
          <a:xfrm>
            <a:off x="2329715" y="2426682"/>
            <a:ext cx="891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5A4198-79A5-BF7E-67A4-6C1BC349B00F}"/>
              </a:ext>
            </a:extLst>
          </p:cNvPr>
          <p:cNvSpPr txBox="1"/>
          <p:nvPr/>
        </p:nvSpPr>
        <p:spPr>
          <a:xfrm>
            <a:off x="2374897" y="2059143"/>
            <a:ext cx="889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AABD21C-DA0B-AEF2-C81A-0DC17721F8CA}"/>
              </a:ext>
            </a:extLst>
          </p:cNvPr>
          <p:cNvSpPr txBox="1"/>
          <p:nvPr/>
        </p:nvSpPr>
        <p:spPr>
          <a:xfrm>
            <a:off x="2374897" y="1803723"/>
            <a:ext cx="889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 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F6734B-4566-E386-40ED-0ED541146602}"/>
              </a:ext>
            </a:extLst>
          </p:cNvPr>
          <p:cNvSpPr txBox="1"/>
          <p:nvPr/>
        </p:nvSpPr>
        <p:spPr>
          <a:xfrm>
            <a:off x="2302679" y="1223940"/>
            <a:ext cx="9612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3AEE32-8DEC-A414-FB39-AD9F05C906CE}"/>
              </a:ext>
            </a:extLst>
          </p:cNvPr>
          <p:cNvSpPr txBox="1"/>
          <p:nvPr/>
        </p:nvSpPr>
        <p:spPr>
          <a:xfrm>
            <a:off x="3334737" y="1485550"/>
            <a:ext cx="734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E408A06-2C2C-BCDA-B2B1-9B00E30BDB09}"/>
              </a:ext>
            </a:extLst>
          </p:cNvPr>
          <p:cNvSpPr txBox="1"/>
          <p:nvPr/>
        </p:nvSpPr>
        <p:spPr>
          <a:xfrm>
            <a:off x="1502229" y="5943452"/>
            <a:ext cx="96665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+mj-cs"/>
              </a:rPr>
              <a:t>Supplement 4B: Western Blot of GAPDH Protein. </a:t>
            </a:r>
          </a:p>
          <a:p>
            <a:r>
              <a:rPr lang="en-US" sz="1400" b="1" dirty="0">
                <a:cs typeface="+mj-cs"/>
              </a:rPr>
              <a:t>N(normal) and T(tumor)</a:t>
            </a:r>
            <a:endParaRPr lang="en-US" sz="14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1576068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74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yammohammadi</dc:creator>
  <cp:lastModifiedBy>Mohammad Najafi</cp:lastModifiedBy>
  <cp:revision>12</cp:revision>
  <dcterms:created xsi:type="dcterms:W3CDTF">2025-12-16T21:01:37Z</dcterms:created>
  <dcterms:modified xsi:type="dcterms:W3CDTF">2025-12-22T12:26:11Z</dcterms:modified>
</cp:coreProperties>
</file>